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64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5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1DDB3D-A751-2230-771F-0DA3674C4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981C3C-DFB1-9D55-3877-2CC7F21DD3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28121-5E3F-4114-1AD4-362B60FBC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65A7D3-78AE-67AB-501B-5B172DADB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C5347-8E2F-8CDF-27D6-7891DC036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08696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50C5F-F117-F356-0629-774F797D1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A6A947-2B2F-F3B9-15D6-62D1C4F3E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A23FD-E809-E0D3-BD8E-D5E81C7B7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BB1C0-AA3B-55C5-1E66-17C74DC4A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D5467-9EFD-A8E4-2487-B4439D3D4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7147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C5F538-DC91-7AA6-09D2-598CD342C1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9A9B37-7557-00C7-D085-377B4FF6F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D4E12-0D43-3F68-E688-ADF3BB436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B26E5-3011-300C-31EF-BD1073969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2650E-61CE-9A1A-F606-7AD5C6698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4361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49FF0-EC54-4BE6-7BB2-F28F759E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112859-E49A-8A5C-9525-7094FC0766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8058DF-1588-FD0C-4E3A-0D6068552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2BD8E-525D-2F1E-F637-BF4DAFA9E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F123BC-C693-61F4-22A2-5B2CF9266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79390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79710-A93A-8101-C051-1C68A2715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079044-E0F7-2998-5D5F-2098D2CD5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E2F07F-D39B-BB57-D27C-90B669502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3C64BD-810B-125B-4852-F1D64C21E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D0E8B-9926-D6BA-A71F-BAB1B4165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53393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D5811-3273-90C8-7846-3B08346D9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60813B-C409-C9F6-5DA2-41012C4C7D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7EB782-B378-4495-420F-AE25AB15F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A19A19-BF4E-AD0E-7CA7-152B39F93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EC775B-D2A0-C38C-B3DF-C8302DFAF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89C786-4875-4EBA-C2F1-0A06DCA4A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810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21E1E-6B8F-86FE-75E6-B1F04940B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FB3D8D-63DF-1941-FE46-7639742BE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2E3C53-052B-0AF4-7CAF-B28F26420A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DC40BA-FC01-28BB-79E3-79C0F6218B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A54B04-BD53-AD6C-2194-E614904CF7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008720-1232-2672-9598-A24C97AB0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518686-57BB-1342-A838-942D32B58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C8A5B2-0978-4434-E81F-441935F8C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7176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53C77-B265-4D6D-269B-3B591AE11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DDC18A-EE33-D778-1528-9D5ED0A4A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39E9C3-3E9F-E0D3-23A0-A509EA57C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020FDF-A17B-43C9-AACE-4333132A3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2486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EBEC57-72BF-2F17-A92F-4D3538C47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4C1C7D-3347-B5B9-50A9-85EB1F8B6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6CF306-9454-7124-1530-25C5FBA05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51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C621E-2A4A-88AD-0843-3B24BA9BF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B1945-E179-B60B-AAC0-5F99058DD3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568E20-E9FE-6750-10CF-06120E5A50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21FF8B-36DC-8B2F-9A0C-B86C27C73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C81924-485A-83FE-8EF3-7A06222A3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D51700-2002-10F0-B2E9-3CE4D9EA0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28664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7622E-7F6A-6478-09AD-FA91EF692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734F5-CA7E-BA24-D0B9-66AE30E00B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1E750D-29BC-5F8D-4B48-D0F1A69B0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B2DAC-9A5E-F296-3E6D-2C59DE83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74634-0393-3924-14DA-485DAC026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8C97FC-6B0C-FBF3-1BA2-19DEFBFF4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603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8739D2-3E70-87E0-49F6-3ABB136C9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AADC0-0839-FB74-E648-32DF6D513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8635D4-9AA1-CD53-9819-4311B3FFD6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8DB55-D7FC-C335-CC63-BD82E94FEB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4B71E-4F27-FB4F-2971-657907EA72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1089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8BD1A4C8-707B-5034-598E-01B069AF9366}"/>
              </a:ext>
            </a:extLst>
          </p:cNvPr>
          <p:cNvGrpSpPr/>
          <p:nvPr/>
        </p:nvGrpSpPr>
        <p:grpSpPr>
          <a:xfrm>
            <a:off x="1269197" y="-19772"/>
            <a:ext cx="9663871" cy="6598465"/>
            <a:chOff x="1269197" y="-19772"/>
            <a:chExt cx="9663871" cy="659846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EE03119-DCBB-D1F0-1928-7CF15B4738D7}"/>
                </a:ext>
              </a:extLst>
            </p:cNvPr>
            <p:cNvSpPr txBox="1"/>
            <p:nvPr/>
          </p:nvSpPr>
          <p:spPr>
            <a:xfrm>
              <a:off x="1269197" y="445904"/>
              <a:ext cx="9653605" cy="64633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A09FD0-1F50-5AEA-2C1F-F09F6CEBCE3B}"/>
                </a:ext>
              </a:extLst>
            </p:cNvPr>
            <p:cNvSpPr txBox="1"/>
            <p:nvPr/>
          </p:nvSpPr>
          <p:spPr>
            <a:xfrm>
              <a:off x="1279463" y="1229375"/>
              <a:ext cx="9653605" cy="1477328"/>
            </a:xfrm>
            <a:prstGeom prst="rect">
              <a:avLst/>
            </a:prstGeom>
            <a:noFill/>
            <a:ln w="28575">
              <a:solidFill>
                <a:schemeClr val="accent6">
                  <a:lumMod val="50000"/>
                </a:schemeClr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337BD85-DD51-1B6D-462A-90967435A35D}"/>
                </a:ext>
              </a:extLst>
            </p:cNvPr>
            <p:cNvSpPr txBox="1"/>
            <p:nvPr/>
          </p:nvSpPr>
          <p:spPr>
            <a:xfrm>
              <a:off x="1952247" y="-14190"/>
              <a:ext cx="966931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685EFE-3386-B6CC-D263-EE914FF45BA9}"/>
                </a:ext>
              </a:extLst>
            </p:cNvPr>
            <p:cNvSpPr txBox="1"/>
            <p:nvPr/>
          </p:nvSpPr>
          <p:spPr>
            <a:xfrm>
              <a:off x="5029882" y="-14533"/>
              <a:ext cx="1896673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 databas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01CF00-3DBB-0386-379E-E83F42DD6FDD}"/>
                </a:ext>
              </a:extLst>
            </p:cNvPr>
            <p:cNvSpPr txBox="1"/>
            <p:nvPr/>
          </p:nvSpPr>
          <p:spPr>
            <a:xfrm>
              <a:off x="1610189" y="651695"/>
              <a:ext cx="1519320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isposal at SWD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3B35F1-6C14-F644-B064-C300C07A21FB}"/>
                </a:ext>
              </a:extLst>
            </p:cNvPr>
            <p:cNvSpPr txBox="1"/>
            <p:nvPr/>
          </p:nvSpPr>
          <p:spPr>
            <a:xfrm>
              <a:off x="1592557" y="148703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mposting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E19CE9-46FB-EBCD-421C-FFFA2A6984B9}"/>
                </a:ext>
              </a:extLst>
            </p:cNvPr>
            <p:cNvSpPr txBox="1"/>
            <p:nvPr/>
          </p:nvSpPr>
          <p:spPr>
            <a:xfrm>
              <a:off x="3620352" y="1367428"/>
              <a:ext cx="4657725" cy="430887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Compost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industrial composting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898D83E-E561-9BAB-4827-0FC33A193865}"/>
                </a:ext>
              </a:extLst>
            </p:cNvPr>
            <p:cNvSpPr txBox="1"/>
            <p:nvPr/>
          </p:nvSpPr>
          <p:spPr>
            <a:xfrm>
              <a:off x="8909570" y="-19772"/>
              <a:ext cx="1742785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nctional Unit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D0F2850-F977-50D9-3FCF-33689E61A5CF}"/>
                </a:ext>
              </a:extLst>
            </p:cNvPr>
            <p:cNvSpPr txBox="1"/>
            <p:nvPr/>
          </p:nvSpPr>
          <p:spPr>
            <a:xfrm>
              <a:off x="8928185" y="665623"/>
              <a:ext cx="1742786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8.64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6B6B430-B164-7BFD-2D59-F505856AAC39}"/>
                </a:ext>
              </a:extLst>
            </p:cNvPr>
            <p:cNvSpPr txBox="1"/>
            <p:nvPr/>
          </p:nvSpPr>
          <p:spPr>
            <a:xfrm>
              <a:off x="8909569" y="1480204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8.64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A3EFF087-1CE8-8161-675F-43FCC52C2EDD}"/>
                </a:ext>
              </a:extLst>
            </p:cNvPr>
            <p:cNvCxnSpPr>
              <a:cxnSpLocks/>
              <a:stCxn id="8" idx="3"/>
            </p:cNvCxnSpPr>
            <p:nvPr/>
          </p:nvCxnSpPr>
          <p:spPr>
            <a:xfrm>
              <a:off x="3129509" y="782500"/>
              <a:ext cx="500150" cy="318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53733127-3196-8A93-67E8-D0558B685BCC}"/>
                </a:ext>
              </a:extLst>
            </p:cNvPr>
            <p:cNvCxnSpPr>
              <a:cxnSpLocks/>
            </p:cNvCxnSpPr>
            <p:nvPr/>
          </p:nvCxnSpPr>
          <p:spPr>
            <a:xfrm>
              <a:off x="8268768" y="1597846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B7328736-2947-86EF-2705-9AC7E0F3F988}"/>
                </a:ext>
              </a:extLst>
            </p:cNvPr>
            <p:cNvCxnSpPr/>
            <p:nvPr/>
          </p:nvCxnSpPr>
          <p:spPr>
            <a:xfrm>
              <a:off x="3177023" y="1621715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F303D37-CFC6-F966-476C-A42599026665}"/>
                </a:ext>
              </a:extLst>
            </p:cNvPr>
            <p:cNvSpPr txBox="1"/>
            <p:nvPr/>
          </p:nvSpPr>
          <p:spPr>
            <a:xfrm>
              <a:off x="1566909" y="212018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6A12E6-CB88-6622-573C-E4602957155D}"/>
                </a:ext>
              </a:extLst>
            </p:cNvPr>
            <p:cNvSpPr txBox="1"/>
            <p:nvPr/>
          </p:nvSpPr>
          <p:spPr>
            <a:xfrm>
              <a:off x="3629659" y="1946826"/>
              <a:ext cx="4657725" cy="600164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65AA4D5-92B4-A352-BE6B-9DA3495158A6}"/>
                </a:ext>
              </a:extLst>
            </p:cNvPr>
            <p:cNvSpPr txBox="1"/>
            <p:nvPr/>
          </p:nvSpPr>
          <p:spPr>
            <a:xfrm>
              <a:off x="8918877" y="2120188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5.59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320B9C2F-9513-290F-9F63-478220AEDBC8}"/>
                </a:ext>
              </a:extLst>
            </p:cNvPr>
            <p:cNvCxnSpPr/>
            <p:nvPr/>
          </p:nvCxnSpPr>
          <p:spPr>
            <a:xfrm>
              <a:off x="8278077" y="2239944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641A66D-95E8-6106-2F3D-14325A21E4A5}"/>
                </a:ext>
              </a:extLst>
            </p:cNvPr>
            <p:cNvCxnSpPr/>
            <p:nvPr/>
          </p:nvCxnSpPr>
          <p:spPr>
            <a:xfrm>
              <a:off x="3177023" y="2263818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60C0AC4-37E6-7E9B-7246-2C52A4A7E2E9}"/>
                </a:ext>
              </a:extLst>
            </p:cNvPr>
            <p:cNvSpPr txBox="1"/>
            <p:nvPr/>
          </p:nvSpPr>
          <p:spPr>
            <a:xfrm>
              <a:off x="1269197" y="2885374"/>
              <a:ext cx="9653605" cy="3693319"/>
            </a:xfrm>
            <a:prstGeom prst="rect">
              <a:avLst/>
            </a:prstGeom>
            <a:noFill/>
            <a:ln w="28575">
              <a:solidFill>
                <a:srgbClr val="00B05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6B35948-EC01-FA43-0994-BFE6F298913A}"/>
                </a:ext>
              </a:extLst>
            </p:cNvPr>
            <p:cNvSpPr txBox="1"/>
            <p:nvPr/>
          </p:nvSpPr>
          <p:spPr>
            <a:xfrm>
              <a:off x="1582291" y="3143037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415637-AA23-AE7E-250B-DCFDADFEB4D9}"/>
                </a:ext>
              </a:extLst>
            </p:cNvPr>
            <p:cNvSpPr txBox="1"/>
            <p:nvPr/>
          </p:nvSpPr>
          <p:spPr>
            <a:xfrm>
              <a:off x="3610086" y="3023427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 by anaerobic diges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D099D9E-0C98-CC0D-DD4E-7DCD0301E7D7}"/>
                </a:ext>
              </a:extLst>
            </p:cNvPr>
            <p:cNvSpPr txBox="1"/>
            <p:nvPr/>
          </p:nvSpPr>
          <p:spPr>
            <a:xfrm>
              <a:off x="8899303" y="3136203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8.64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8DD66652-9C5D-034D-B550-7F0E15024F4B}"/>
                </a:ext>
              </a:extLst>
            </p:cNvPr>
            <p:cNvCxnSpPr>
              <a:cxnSpLocks/>
            </p:cNvCxnSpPr>
            <p:nvPr/>
          </p:nvCxnSpPr>
          <p:spPr>
            <a:xfrm>
              <a:off x="8258502" y="325384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7C7360CC-2DF1-4801-01D6-BF32AF98C9CF}"/>
                </a:ext>
              </a:extLst>
            </p:cNvPr>
            <p:cNvCxnSpPr/>
            <p:nvPr/>
          </p:nvCxnSpPr>
          <p:spPr>
            <a:xfrm>
              <a:off x="3166757" y="3277714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7C878B-23BB-1175-E90C-683360734DA0}"/>
                </a:ext>
              </a:extLst>
            </p:cNvPr>
            <p:cNvSpPr txBox="1"/>
            <p:nvPr/>
          </p:nvSpPr>
          <p:spPr>
            <a:xfrm>
              <a:off x="1592557" y="4843446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8E68EEC-32F5-BAA5-343A-CCA8A2B284AB}"/>
                </a:ext>
              </a:extLst>
            </p:cNvPr>
            <p:cNvSpPr txBox="1"/>
            <p:nvPr/>
          </p:nvSpPr>
          <p:spPr>
            <a:xfrm>
              <a:off x="3619393" y="3602825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0FB4329-FD38-C7D2-ACA0-02ED0C1E3754}"/>
                </a:ext>
              </a:extLst>
            </p:cNvPr>
            <p:cNvSpPr txBox="1"/>
            <p:nvPr/>
          </p:nvSpPr>
          <p:spPr>
            <a:xfrm>
              <a:off x="8908611" y="3776187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5.59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AFB3D94B-B6FC-9C91-85A4-F5D123E1CB37}"/>
                </a:ext>
              </a:extLst>
            </p:cNvPr>
            <p:cNvCxnSpPr/>
            <p:nvPr/>
          </p:nvCxnSpPr>
          <p:spPr>
            <a:xfrm>
              <a:off x="8267811" y="3895943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7711A44-F5AF-5B8D-2B11-A979D0C33382}"/>
                </a:ext>
              </a:extLst>
            </p:cNvPr>
            <p:cNvSpPr txBox="1"/>
            <p:nvPr/>
          </p:nvSpPr>
          <p:spPr>
            <a:xfrm>
              <a:off x="3619393" y="4412559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- Coal – Transformation - Electricity, high voltage {ZA}| electricity production, hard coal, supercritical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A204558-D81C-C63F-3F63-626F4234A656}"/>
                </a:ext>
              </a:extLst>
            </p:cNvPr>
            <p:cNvSpPr txBox="1"/>
            <p:nvPr/>
          </p:nvSpPr>
          <p:spPr>
            <a:xfrm>
              <a:off x="8918877" y="4497198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48.12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07642719-8217-8229-F1C7-EF16D8B4799A}"/>
                </a:ext>
              </a:extLst>
            </p:cNvPr>
            <p:cNvCxnSpPr/>
            <p:nvPr/>
          </p:nvCxnSpPr>
          <p:spPr>
            <a:xfrm>
              <a:off x="8278077" y="4605127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353F055-1557-F6FB-4D1A-752DDDCC56C2}"/>
                </a:ext>
              </a:extLst>
            </p:cNvPr>
            <p:cNvSpPr txBox="1"/>
            <p:nvPr/>
          </p:nvSpPr>
          <p:spPr>
            <a:xfrm>
              <a:off x="3619393" y="5016027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– Hydro – Reservoir - Transformation - Electricity, high voltage {ZA}| electricity production, hydro, reservoir, non-alpine reg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0D97560-D7CC-FB82-5F05-5E8074B80B46}"/>
                </a:ext>
              </a:extLst>
            </p:cNvPr>
            <p:cNvSpPr txBox="1"/>
            <p:nvPr/>
          </p:nvSpPr>
          <p:spPr>
            <a:xfrm>
              <a:off x="8908611" y="5189389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32.08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BCBD9778-E374-B43B-CB67-1D0BFE844069}"/>
                </a:ext>
              </a:extLst>
            </p:cNvPr>
            <p:cNvCxnSpPr/>
            <p:nvPr/>
          </p:nvCxnSpPr>
          <p:spPr>
            <a:xfrm>
              <a:off x="8267811" y="5309145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Left Brace 63">
              <a:extLst>
                <a:ext uri="{FF2B5EF4-FFF2-40B4-BE49-F238E27FC236}">
                  <a16:creationId xmlns:a16="http://schemas.microsoft.com/office/drawing/2014/main" id="{B2321033-F838-49D3-D336-0C6B69803762}"/>
                </a:ext>
              </a:extLst>
            </p:cNvPr>
            <p:cNvSpPr/>
            <p:nvPr/>
          </p:nvSpPr>
          <p:spPr>
            <a:xfrm>
              <a:off x="3261359" y="3602825"/>
              <a:ext cx="368299" cy="2751278"/>
            </a:xfrm>
            <a:prstGeom prst="leftBrac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666B8AA-CB19-6F41-948E-116FEC5AEBD6}"/>
                </a:ext>
              </a:extLst>
            </p:cNvPr>
            <p:cNvSpPr txBox="1"/>
            <p:nvPr/>
          </p:nvSpPr>
          <p:spPr>
            <a:xfrm>
              <a:off x="3649873" y="5767867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Materials - Fuels – Oil – Propone/Butane - Transformation - Liquefied petroleum gas {ZA}| liquefied petroleum gas production, petroleum refinery opera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D45CE1E-772B-5116-B4A0-AB3835E33235}"/>
                </a:ext>
              </a:extLst>
            </p:cNvPr>
            <p:cNvSpPr txBox="1"/>
            <p:nvPr/>
          </p:nvSpPr>
          <p:spPr>
            <a:xfrm>
              <a:off x="8939091" y="5941229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21.10 kg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DBA7978B-DCAB-5806-F251-F72C953E9C9F}"/>
                </a:ext>
              </a:extLst>
            </p:cNvPr>
            <p:cNvCxnSpPr/>
            <p:nvPr/>
          </p:nvCxnSpPr>
          <p:spPr>
            <a:xfrm>
              <a:off x="8298291" y="6060985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7D03729-9359-6FC0-FBA1-A43F52CAD557}"/>
                </a:ext>
              </a:extLst>
            </p:cNvPr>
            <p:cNvSpPr txBox="1"/>
            <p:nvPr/>
          </p:nvSpPr>
          <p:spPr>
            <a:xfrm>
              <a:off x="3629659" y="570241"/>
              <a:ext cx="4657725" cy="43088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open dump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0A2888D3-664F-B557-7A26-0B73A24CB713}"/>
                </a:ext>
              </a:extLst>
            </p:cNvPr>
            <p:cNvCxnSpPr>
              <a:cxnSpLocks/>
            </p:cNvCxnSpPr>
            <p:nvPr/>
          </p:nvCxnSpPr>
          <p:spPr>
            <a:xfrm>
              <a:off x="8279556" y="78568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88409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</TotalTime>
  <Words>246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bu, Trust</dc:creator>
  <cp:lastModifiedBy>Nhubu, Trust</cp:lastModifiedBy>
  <cp:revision>8</cp:revision>
  <dcterms:created xsi:type="dcterms:W3CDTF">2024-01-20T17:04:47Z</dcterms:created>
  <dcterms:modified xsi:type="dcterms:W3CDTF">2024-05-14T07:12:21Z</dcterms:modified>
</cp:coreProperties>
</file>